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8" autoAdjust="0"/>
    <p:restoredTop sz="94660"/>
  </p:normalViewPr>
  <p:slideViewPr>
    <p:cSldViewPr snapToGrid="0">
      <p:cViewPr>
        <p:scale>
          <a:sx n="220" d="100"/>
          <a:sy n="220" d="100"/>
        </p:scale>
        <p:origin x="0" y="-43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3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911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083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563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51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404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28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98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151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62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905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D2E12-415B-44F3-9605-B30C345042C0}" type="datetimeFigureOut">
              <a:rPr lang="en-US" smtClean="0"/>
              <a:t>5/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079A9-9BBA-44A2-A41A-FF838C27A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01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8077455"/>
              </p:ext>
            </p:extLst>
          </p:nvPr>
        </p:nvGraphicFramePr>
        <p:xfrm>
          <a:off x="3066921" y="4651424"/>
          <a:ext cx="885369" cy="866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1" name="Image" r:id="rId3" imgW="7860240" imgH="7695000" progId="Photoshop.Image.12">
                  <p:embed/>
                </p:oleObj>
              </mc:Choice>
              <mc:Fallback>
                <p:oleObj name="Image" r:id="rId3" imgW="7860240" imgH="769500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66921" y="4651424"/>
                        <a:ext cx="885369" cy="866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4676805"/>
              </p:ext>
            </p:extLst>
          </p:nvPr>
        </p:nvGraphicFramePr>
        <p:xfrm>
          <a:off x="2389635" y="3248152"/>
          <a:ext cx="2666236" cy="2334313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584639"/>
                <a:gridCol w="1030392"/>
                <a:gridCol w="1051205"/>
              </a:tblGrid>
              <a:tr h="371759">
                <a:tc>
                  <a:txBody>
                    <a:bodyPr/>
                    <a:lstStyle/>
                    <a:p>
                      <a:endParaRPr lang="en-US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D. </a:t>
                      </a:r>
                      <a:r>
                        <a:rPr lang="en-GB" sz="1200" i="1" dirty="0" err="1" smtClean="0"/>
                        <a:t>cannabina</a:t>
                      </a:r>
                      <a:endParaRPr lang="en-US" sz="1200" i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200" i="1" dirty="0" smtClean="0"/>
                        <a:t>D. </a:t>
                      </a:r>
                      <a:r>
                        <a:rPr lang="en-GB" sz="1200" i="1" dirty="0" err="1" smtClean="0"/>
                        <a:t>glomerata</a:t>
                      </a:r>
                      <a:endParaRPr lang="en-US" sz="1200" i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976473">
                <a:tc>
                  <a:txBody>
                    <a:bodyPr/>
                    <a:lstStyle/>
                    <a:p>
                      <a:pPr algn="ctr"/>
                      <a:r>
                        <a:rPr lang="en-GB" b="1" dirty="0" smtClean="0"/>
                        <a:t>Dg1</a:t>
                      </a:r>
                      <a:endParaRPr lang="en-US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986081">
                <a:tc>
                  <a:txBody>
                    <a:bodyPr/>
                    <a:lstStyle/>
                    <a:p>
                      <a:pPr algn="ctr"/>
                      <a:r>
                        <a:rPr lang="en-GB" b="1" dirty="0" smtClean="0"/>
                        <a:t>Dg2</a:t>
                      </a:r>
                      <a:endParaRPr lang="en-US" b="1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3268808"/>
              </p:ext>
            </p:extLst>
          </p:nvPr>
        </p:nvGraphicFramePr>
        <p:xfrm>
          <a:off x="3066306" y="3690126"/>
          <a:ext cx="885984" cy="8437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2" name="Image" r:id="rId5" imgW="7999920" imgH="7619040" progId="Photoshop.Image.12">
                  <p:embed/>
                </p:oleObj>
              </mc:Choice>
              <mc:Fallback>
                <p:oleObj name="Image" r:id="rId5" imgW="7999920" imgH="761904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66306" y="3690126"/>
                        <a:ext cx="885984" cy="8437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2429969"/>
              </p:ext>
            </p:extLst>
          </p:nvPr>
        </p:nvGraphicFramePr>
        <p:xfrm>
          <a:off x="4110429" y="3690126"/>
          <a:ext cx="846667" cy="8466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Image" r:id="rId7" imgW="8330040" imgH="8330040" progId="Photoshop.Image.12">
                  <p:embed/>
                </p:oleObj>
              </mc:Choice>
              <mc:Fallback>
                <p:oleObj name="Image" r:id="rId7" imgW="8330040" imgH="833004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10429" y="3690126"/>
                        <a:ext cx="846667" cy="8466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1306124" y="1945645"/>
            <a:ext cx="483325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/>
              <a:t>Additional file 4. </a:t>
            </a:r>
            <a:r>
              <a:rPr lang="en-GB" sz="1200" dirty="0" smtClean="0"/>
              <a:t>Both </a:t>
            </a:r>
            <a:r>
              <a:rPr lang="en-GB" sz="1200" dirty="0" err="1" smtClean="0"/>
              <a:t>inocula</a:t>
            </a:r>
            <a:r>
              <a:rPr lang="en-GB" sz="1200" dirty="0" smtClean="0"/>
              <a:t>, </a:t>
            </a:r>
            <a:r>
              <a:rPr lang="en-GB" sz="1200" i="1" dirty="0" err="1" smtClean="0"/>
              <a:t>Candidatus</a:t>
            </a:r>
            <a:r>
              <a:rPr lang="en-GB" sz="1200" i="1" dirty="0" smtClean="0"/>
              <a:t> </a:t>
            </a:r>
            <a:r>
              <a:rPr lang="en-GB" sz="1200" dirty="0" err="1" smtClean="0"/>
              <a:t>Frankia</a:t>
            </a:r>
            <a:r>
              <a:rPr lang="en-GB" sz="1200" dirty="0" smtClean="0"/>
              <a:t> </a:t>
            </a:r>
            <a:r>
              <a:rPr lang="en-GB" sz="1200" dirty="0" err="1" smtClean="0"/>
              <a:t>datiscae</a:t>
            </a:r>
            <a:r>
              <a:rPr lang="en-GB" sz="1200" dirty="0" smtClean="0"/>
              <a:t> Dg1 and the strain assemblage Dg2, can induce nodules on D. </a:t>
            </a:r>
            <a:r>
              <a:rPr lang="en-GB" sz="1200" i="1" dirty="0" err="1" smtClean="0"/>
              <a:t>cannabina</a:t>
            </a:r>
            <a:r>
              <a:rPr lang="en-GB" sz="1200" dirty="0" smtClean="0"/>
              <a:t> as well as on </a:t>
            </a:r>
            <a:r>
              <a:rPr lang="en-GB" sz="1200" i="1" dirty="0" smtClean="0"/>
              <a:t>D. </a:t>
            </a:r>
            <a:r>
              <a:rPr lang="en-GB" sz="1200" i="1" dirty="0" err="1" smtClean="0"/>
              <a:t>glomerata</a:t>
            </a:r>
            <a:r>
              <a:rPr lang="en-GB" sz="1200" i="1" dirty="0" smtClean="0"/>
              <a:t>. </a:t>
            </a:r>
            <a:r>
              <a:rPr lang="en-GB" sz="1200" dirty="0" smtClean="0"/>
              <a:t>Ca. 3 months old plants grown in poor soil were inoculated with crushed nodules. Harvest took place six weeks after inoculation. Pictures of typical nodules are shown. Size bars denote 2 mm.</a:t>
            </a:r>
            <a:endParaRPr lang="en-US" sz="1200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6080029"/>
              </p:ext>
            </p:extLst>
          </p:nvPr>
        </p:nvGraphicFramePr>
        <p:xfrm>
          <a:off x="4079937" y="4651936"/>
          <a:ext cx="907650" cy="86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Image" r:id="rId9" imgW="8075880" imgH="7707600" progId="Photoshop.Image.12">
                  <p:embed/>
                </p:oleObj>
              </mc:Choice>
              <mc:Fallback>
                <p:oleObj name="Image" r:id="rId9" imgW="8075880" imgH="770760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079937" y="4651936"/>
                        <a:ext cx="907650" cy="866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28839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77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Image</vt:lpstr>
      <vt:lpstr>Adobe Photoshop Imag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arina Pawlowska</dc:creator>
  <cp:lastModifiedBy>Katharina Pawlowska</cp:lastModifiedBy>
  <cp:revision>8</cp:revision>
  <dcterms:created xsi:type="dcterms:W3CDTF">2016-05-05T12:31:09Z</dcterms:created>
  <dcterms:modified xsi:type="dcterms:W3CDTF">2016-05-06T14:22:25Z</dcterms:modified>
</cp:coreProperties>
</file>